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705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9144000" cy="6858000" type="screen4x3"/>
  <p:notesSz cx="6858000" cy="9774238"/>
  <p:kinsoku lang="ja-JP" invalStChars="" invalEndChars="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AEC5E"/>
    <a:srgbClr val="A2C1FE"/>
    <a:srgbClr val="FFFFFF"/>
    <a:srgbClr val="FDC0E5"/>
    <a:srgbClr val="F39FD1"/>
    <a:srgbClr val="A50021"/>
    <a:srgbClr val="000066"/>
    <a:srgbClr val="4500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2" d="100"/>
          <a:sy n="92" d="100"/>
        </p:scale>
        <p:origin x="-118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99313788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657725"/>
            <a:ext cx="5029200" cy="441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488" tIns="44450" rIns="90488" bIns="4445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noProof="0" smtClean="0"/>
              <a:t>Click to edit Master text styles</a:t>
            </a:r>
          </a:p>
          <a:p>
            <a:pPr lvl="1"/>
            <a:r>
              <a:rPr lang="en-GB" noProof="0" smtClean="0"/>
              <a:t>Second level</a:t>
            </a:r>
          </a:p>
          <a:p>
            <a:pPr lvl="2"/>
            <a:r>
              <a:rPr lang="en-GB" noProof="0" smtClean="0"/>
              <a:t>Third level</a:t>
            </a:r>
          </a:p>
          <a:p>
            <a:pPr lvl="3"/>
            <a:r>
              <a:rPr lang="en-GB" noProof="0" smtClean="0"/>
              <a:t>Fourth level</a:t>
            </a:r>
          </a:p>
          <a:p>
            <a:pPr lvl="4"/>
            <a:r>
              <a:rPr lang="en-GB" noProof="0" smtClean="0"/>
              <a:t>Fifth level</a:t>
            </a:r>
          </a:p>
        </p:txBody>
      </p:sp>
      <p:sp>
        <p:nvSpPr>
          <p:cNvPr id="3075" name="Rectangle 3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4588" y="849313"/>
            <a:ext cx="4568825" cy="342582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</p:spTree>
    <p:extLst>
      <p:ext uri="{BB962C8B-B14F-4D97-AF65-F5344CB8AC3E}">
        <p14:creationId xmlns:p14="http://schemas.microsoft.com/office/powerpoint/2010/main" val="285357477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7620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Arial" charset="0"/>
      </a:defRPr>
    </a:lvl1pPr>
    <a:lvl2pPr marL="457200" algn="l" defTabSz="7620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Arial" charset="0"/>
      </a:defRPr>
    </a:lvl2pPr>
    <a:lvl3pPr marL="914400" algn="l" defTabSz="7620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Arial" charset="0"/>
      </a:defRPr>
    </a:lvl3pPr>
    <a:lvl4pPr marL="1371600" algn="l" defTabSz="7620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Arial" charset="0"/>
      </a:defRPr>
    </a:lvl4pPr>
    <a:lvl5pPr marL="1828800" algn="l" defTabSz="7620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Check if other </a:t>
            </a:r>
            <a:r>
              <a:rPr lang="en-GB" smtClean="0"/>
              <a:t>controls available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982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FA1086-8A53-409F-A5FD-73CF41CBB54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460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99B69D-5D36-4EDA-9FED-1EF8471B0EB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0313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FCD7CF-F184-4DE2-B423-E2820263448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8976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39A018-4B57-4E76-9409-B64DACEC132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345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4F95E2-B98E-4145-AA22-C60050D2BC7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2641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CED581-C064-4559-B872-02B214EFCEE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8170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9B77A7-0B2C-4EAF-BB1D-826F7CD9DFA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2035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830CE5-8212-4584-96A1-E5735729F61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5873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14EC6CB-4654-476B-8A2D-BE1F9436483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3177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2161DF-E40C-4297-90FD-2C3B81D7F64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691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28D3A7-56F1-45E6-A33F-0B7FC257F9F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40065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ext styles</a:t>
            </a:r>
          </a:p>
          <a:p>
            <a:pPr lvl="1"/>
            <a:r>
              <a:rPr lang="en-GB" altLang="en-US" smtClean="0"/>
              <a:t>Second level</a:t>
            </a:r>
          </a:p>
          <a:p>
            <a:pPr lvl="2"/>
            <a:r>
              <a:rPr lang="en-GB" altLang="en-US" smtClean="0"/>
              <a:t>Third level</a:t>
            </a:r>
          </a:p>
          <a:p>
            <a:pPr lvl="3"/>
            <a:r>
              <a:rPr lang="en-GB" altLang="en-US" smtClean="0"/>
              <a:t>Fourth level</a:t>
            </a:r>
          </a:p>
          <a:p>
            <a:pPr lvl="4"/>
            <a:r>
              <a:rPr lang="en-GB" altLang="en-US" smtClean="0"/>
              <a:t>Fifth level</a:t>
            </a:r>
          </a:p>
        </p:txBody>
      </p:sp>
      <p:sp>
        <p:nvSpPr>
          <p:cNvPr id="69636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9637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9638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A2E179BA-A649-4EE6-98F7-870B2302A1A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6" r:id="rId1"/>
    <p:sldLayoutId id="2147483707" r:id="rId2"/>
    <p:sldLayoutId id="2147483708" r:id="rId3"/>
    <p:sldLayoutId id="2147483709" r:id="rId4"/>
    <p:sldLayoutId id="2147483710" r:id="rId5"/>
    <p:sldLayoutId id="2147483711" r:id="rId6"/>
    <p:sldLayoutId id="2147483712" r:id="rId7"/>
    <p:sldLayoutId id="2147483713" r:id="rId8"/>
    <p:sldLayoutId id="2147483714" r:id="rId9"/>
    <p:sldLayoutId id="2147483715" r:id="rId10"/>
    <p:sldLayoutId id="2147483716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683568" y="5013176"/>
            <a:ext cx="7488832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1 Fig.</a:t>
            </a:r>
            <a:r>
              <a:rPr kumimoji="0" lang="en-GB" alt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Demonstration</a:t>
            </a:r>
            <a:r>
              <a:rPr kumimoji="0" lang="en-GB" alt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f 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recombinant TS activity by complementation of TS-deficient (</a:t>
            </a:r>
            <a:r>
              <a:rPr kumimoji="0" lang="en-GB" alt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hyA</a:t>
            </a:r>
            <a:r>
              <a:rPr kumimoji="0" lang="en-GB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) </a:t>
            </a:r>
            <a:r>
              <a:rPr kumimoji="0" lang="en-GB" alt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E. coli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  Positive control is </a:t>
            </a:r>
            <a:r>
              <a:rPr kumimoji="0" lang="en-GB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hyA</a:t>
            </a:r>
            <a:r>
              <a:rPr kumimoji="0" lang="en-GB" altLang="en-US" sz="1200" b="0" i="1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(endogenous TS expressed), negative control is </a:t>
            </a:r>
            <a:r>
              <a:rPr kumimoji="0" lang="en-GB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hyA</a:t>
            </a:r>
            <a:r>
              <a:rPr kumimoji="0" lang="en-GB" altLang="en-US" sz="1200" b="0" i="1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(endogenous TS deleted), both transformed with empty pET15b-Tsf-TEV vector. Successful complementation of </a:t>
            </a:r>
            <a:r>
              <a:rPr kumimoji="0" lang="en-GB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hyA</a:t>
            </a:r>
            <a:r>
              <a:rPr kumimoji="0" lang="en-GB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is shown with </a:t>
            </a:r>
            <a:r>
              <a:rPr kumimoji="0" lang="en-GB" alt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Lm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DHFR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TS (recombinant TS) as control. Recombinant </a:t>
            </a:r>
            <a:r>
              <a:rPr kumimoji="0" lang="en-GB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. brucei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TS activity confirmed after 72 h for Tsf-</a:t>
            </a:r>
            <a:r>
              <a:rPr kumimoji="0" lang="en-GB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b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DHFR-TS, also for His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6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tagged </a:t>
            </a:r>
            <a:r>
              <a:rPr kumimoji="0" lang="en-GB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b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DHFR-TS.  Tsf-</a:t>
            </a:r>
            <a:r>
              <a:rPr kumimoji="0" lang="en-GB" alt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b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S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lacking the DHFR domain, did not complement.  For re-plating, single colonies from initial screening were grown to turbidity in LB media 50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  <a:ea typeface="Times New Roman" pitchFamily="18" charset="0"/>
                <a:cs typeface="Times New Roman" pitchFamily="18" charset="0"/>
              </a:rPr>
              <a:t>m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g ml</a:t>
            </a:r>
            <a:r>
              <a:rPr kumimoji="0" lang="en-GB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1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carbenicillin, as described in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ethods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ection, prior to plating.  </a:t>
            </a: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5696" y="188640"/>
            <a:ext cx="4787956" cy="4658988"/>
          </a:xfrm>
          <a:prstGeom prst="rect">
            <a:avLst/>
          </a:prstGeom>
        </p:spPr>
      </p:pic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Blank 3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99CCFF"/>
      </a:accent1>
      <a:accent2>
        <a:srgbClr val="CCCCFF"/>
      </a:accent2>
      <a:accent3>
        <a:srgbClr val="FFFFFF"/>
      </a:accent3>
      <a:accent4>
        <a:srgbClr val="000000"/>
      </a:accent4>
      <a:accent5>
        <a:srgbClr val="CAE2FF"/>
      </a:accent5>
      <a:accent6>
        <a:srgbClr val="B9B9E7"/>
      </a:accent6>
      <a:hlink>
        <a:srgbClr val="3333CC"/>
      </a:hlink>
      <a:folHlink>
        <a:srgbClr val="AF67FF"/>
      </a:folHlink>
    </a:clrScheme>
    <a:fontScheme name="Blank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1270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0488" tIns="44450" rIns="90488" bIns="4445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1270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0488" tIns="44450" rIns="90488" bIns="4445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Blank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31</TotalTime>
  <Pages>1</Pages>
  <Words>22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Company>uo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lan H Fairlamb</dc:creator>
  <cp:lastModifiedBy>Alan Fairlamb</cp:lastModifiedBy>
  <cp:revision>8</cp:revision>
  <cp:lastPrinted>1997-05-28T13:01:58Z</cp:lastPrinted>
  <dcterms:created xsi:type="dcterms:W3CDTF">2011-04-14T15:23:16Z</dcterms:created>
  <dcterms:modified xsi:type="dcterms:W3CDTF">2016-03-06T10:27:22Z</dcterms:modified>
</cp:coreProperties>
</file>